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3318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80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111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585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379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102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288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85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132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102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85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503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726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889B9C93-6E4B-A0D4-7C1C-B801696A71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59"/>
          <a:stretch>
            <a:fillRect/>
          </a:stretch>
        </p:blipFill>
        <p:spPr>
          <a:xfrm>
            <a:off x="2233551" y="1908829"/>
            <a:ext cx="2390898" cy="3871685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73E9A91-84DC-9CA8-A51F-04F75E83D9FD}"/>
              </a:ext>
            </a:extLst>
          </p:cNvPr>
          <p:cNvSpPr txBox="1"/>
          <p:nvPr/>
        </p:nvSpPr>
        <p:spPr>
          <a:xfrm>
            <a:off x="549000" y="6642333"/>
            <a:ext cx="5760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candesartan and telmisartan on invasive activity of bladder cancer cells in vitro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well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vasion assay of angiotensin II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ceptor 1 overexpressing cells (AGTR1) and control (Ctrl) T24 cells treated with 10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varying concentrations of candesartan and telmisartan. Data are presented as mean ± SEM of percent invasion relative to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timulated control (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3). *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 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 0.05, compared with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timulated control by one-way ANOVA with Dunnett’s multiple comparison test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7078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92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神沼　修</dc:creator>
  <cp:lastModifiedBy>神沼　修</cp:lastModifiedBy>
  <cp:revision>5</cp:revision>
  <dcterms:created xsi:type="dcterms:W3CDTF">2025-07-04T02:55:30Z</dcterms:created>
  <dcterms:modified xsi:type="dcterms:W3CDTF">2025-10-22T03:48:51Z</dcterms:modified>
</cp:coreProperties>
</file>